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36">
  <p:sldMasterIdLst>
    <p:sldMasterId id="2147483660" r:id="rId1"/>
  </p:sldMasterIdLst>
  <p:sldIdLst>
    <p:sldId id="369" r:id="rId2"/>
    <p:sldId id="361" r:id="rId3"/>
    <p:sldId id="373" r:id="rId4"/>
    <p:sldId id="362" r:id="rId5"/>
    <p:sldId id="357" r:id="rId6"/>
    <p:sldId id="372" r:id="rId7"/>
    <p:sldId id="356" r:id="rId8"/>
    <p:sldId id="370" r:id="rId9"/>
    <p:sldId id="371" r:id="rId10"/>
    <p:sldId id="262" r:id="rId11"/>
    <p:sldId id="364" r:id="rId12"/>
    <p:sldId id="375" r:id="rId13"/>
    <p:sldId id="374" r:id="rId1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CDCA0EA-02B5-4EE3-9AB3-C9574FE8A2BE}" v="3" dt="2025-05-29T20:54:38.54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903" autoAdjust="0"/>
    <p:restoredTop sz="94694"/>
  </p:normalViewPr>
  <p:slideViewPr>
    <p:cSldViewPr snapToGrid="0">
      <p:cViewPr>
        <p:scale>
          <a:sx n="125" d="100"/>
          <a:sy n="125" d="100"/>
        </p:scale>
        <p:origin x="1435" y="-319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ximilian Seidl" userId="88048d6d7a2db45f" providerId="LiveId" clId="{FCDCA0EA-02B5-4EE3-9AB3-C9574FE8A2BE}"/>
    <pc:docChg chg="custSel addSld modSld">
      <pc:chgData name="Maximilian Seidl" userId="88048d6d7a2db45f" providerId="LiveId" clId="{FCDCA0EA-02B5-4EE3-9AB3-C9574FE8A2BE}" dt="2025-05-29T21:04:32.336" v="299" actId="14100"/>
      <pc:docMkLst>
        <pc:docMk/>
      </pc:docMkLst>
      <pc:sldChg chg="modSp mod">
        <pc:chgData name="Maximilian Seidl" userId="88048d6d7a2db45f" providerId="LiveId" clId="{FCDCA0EA-02B5-4EE3-9AB3-C9574FE8A2BE}" dt="2025-05-29T20:48:45.909" v="2" actId="20577"/>
        <pc:sldMkLst>
          <pc:docMk/>
          <pc:sldMk cId="2452990473" sldId="262"/>
        </pc:sldMkLst>
        <pc:spChg chg="mod">
          <ac:chgData name="Maximilian Seidl" userId="88048d6d7a2db45f" providerId="LiveId" clId="{FCDCA0EA-02B5-4EE3-9AB3-C9574FE8A2BE}" dt="2025-05-29T20:48:45.909" v="2" actId="20577"/>
          <ac:spMkLst>
            <pc:docMk/>
            <pc:sldMk cId="2452990473" sldId="262"/>
            <ac:spMk id="5" creationId="{E326EE8B-4283-2205-78FD-2870AC686618}"/>
          </ac:spMkLst>
        </pc:spChg>
      </pc:sldChg>
      <pc:sldChg chg="modSp add mod">
        <pc:chgData name="Maximilian Seidl" userId="88048d6d7a2db45f" providerId="LiveId" clId="{FCDCA0EA-02B5-4EE3-9AB3-C9574FE8A2BE}" dt="2025-05-29T20:53:02.035" v="62" actId="20577"/>
        <pc:sldMkLst>
          <pc:docMk/>
          <pc:sldMk cId="1770068264" sldId="370"/>
        </pc:sldMkLst>
        <pc:spChg chg="mod">
          <ac:chgData name="Maximilian Seidl" userId="88048d6d7a2db45f" providerId="LiveId" clId="{FCDCA0EA-02B5-4EE3-9AB3-C9574FE8A2BE}" dt="2025-05-29T20:53:02.035" v="62" actId="20577"/>
          <ac:spMkLst>
            <pc:docMk/>
            <pc:sldMk cId="1770068264" sldId="370"/>
            <ac:spMk id="5" creationId="{A1C260B4-0B34-C03E-0285-5D138DEBF66A}"/>
          </ac:spMkLst>
        </pc:spChg>
      </pc:sldChg>
      <pc:sldChg chg="addSp delSp modSp add mod">
        <pc:chgData name="Maximilian Seidl" userId="88048d6d7a2db45f" providerId="LiveId" clId="{FCDCA0EA-02B5-4EE3-9AB3-C9574FE8A2BE}" dt="2025-05-29T21:04:32.336" v="299" actId="14100"/>
        <pc:sldMkLst>
          <pc:docMk/>
          <pc:sldMk cId="1830579809" sldId="371"/>
        </pc:sldMkLst>
        <pc:spChg chg="mod">
          <ac:chgData name="Maximilian Seidl" userId="88048d6d7a2db45f" providerId="LiveId" clId="{FCDCA0EA-02B5-4EE3-9AB3-C9574FE8A2BE}" dt="2025-05-29T21:04:32.336" v="299" actId="14100"/>
          <ac:spMkLst>
            <pc:docMk/>
            <pc:sldMk cId="1830579809" sldId="371"/>
            <ac:spMk id="2" creationId="{19BC727E-7873-2468-408E-3572F476A283}"/>
          </ac:spMkLst>
        </pc:spChg>
        <pc:picChg chg="del">
          <ac:chgData name="Maximilian Seidl" userId="88048d6d7a2db45f" providerId="LiveId" clId="{FCDCA0EA-02B5-4EE3-9AB3-C9574FE8A2BE}" dt="2025-05-29T20:53:08.512" v="63" actId="478"/>
          <ac:picMkLst>
            <pc:docMk/>
            <pc:sldMk cId="1830579809" sldId="371"/>
            <ac:picMk id="4" creationId="{285F7C2E-BD63-2254-19C3-E8BDF2BD4A82}"/>
          </ac:picMkLst>
        </pc:picChg>
        <pc:picChg chg="add mod">
          <ac:chgData name="Maximilian Seidl" userId="88048d6d7a2db45f" providerId="LiveId" clId="{FCDCA0EA-02B5-4EE3-9AB3-C9574FE8A2BE}" dt="2025-05-29T20:55:00.122" v="75" actId="1076"/>
          <ac:picMkLst>
            <pc:docMk/>
            <pc:sldMk cId="1830579809" sldId="371"/>
            <ac:picMk id="5" creationId="{F61FDB43-29B1-945D-3079-C719F228589D}"/>
          </ac:picMkLst>
        </pc:picChg>
        <pc:picChg chg="add mod">
          <ac:chgData name="Maximilian Seidl" userId="88048d6d7a2db45f" providerId="LiveId" clId="{FCDCA0EA-02B5-4EE3-9AB3-C9574FE8A2BE}" dt="2025-05-29T20:55:00.122" v="75" actId="1076"/>
          <ac:picMkLst>
            <pc:docMk/>
            <pc:sldMk cId="1830579809" sldId="371"/>
            <ac:picMk id="7" creationId="{E860B093-69F1-ACD4-2790-4AB8073B007E}"/>
          </ac:picMkLst>
        </pc:picChg>
      </pc:sldChg>
    </pc:docChg>
  </pc:docChgLst>
  <pc:docChgLst>
    <pc:chgData name="Maximilian Seidl" userId="88048d6d7a2db45f" providerId="LiveId" clId="{55F8851E-16BC-45D0-9D9E-AB50B116FAF3}"/>
    <pc:docChg chg="modSld">
      <pc:chgData name="Maximilian Seidl" userId="88048d6d7a2db45f" providerId="LiveId" clId="{55F8851E-16BC-45D0-9D9E-AB50B116FAF3}" dt="2025-05-30T13:56:00.868" v="2" actId="20577"/>
      <pc:docMkLst>
        <pc:docMk/>
      </pc:docMkLst>
      <pc:sldChg chg="modSp mod">
        <pc:chgData name="Maximilian Seidl" userId="88048d6d7a2db45f" providerId="LiveId" clId="{55F8851E-16BC-45D0-9D9E-AB50B116FAF3}" dt="2025-05-30T13:56:00.868" v="2" actId="20577"/>
        <pc:sldMkLst>
          <pc:docMk/>
          <pc:sldMk cId="365390168" sldId="364"/>
        </pc:sldMkLst>
        <pc:spChg chg="mod">
          <ac:chgData name="Maximilian Seidl" userId="88048d6d7a2db45f" providerId="LiveId" clId="{55F8851E-16BC-45D0-9D9E-AB50B116FAF3}" dt="2025-05-30T13:56:00.868" v="2" actId="20577"/>
          <ac:spMkLst>
            <pc:docMk/>
            <pc:sldMk cId="365390168" sldId="364"/>
            <ac:spMk id="4" creationId="{03EC2548-E70C-3B4E-A88F-B804B65D0F3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2348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233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6455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9874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0178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1225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6599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1413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9128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0481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8708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D05938-0D00-4E12-8A92-1A5C7A3A0E6F}" type="datetimeFigureOut">
              <a:rPr lang="de-DE" smtClean="0"/>
              <a:t>31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5F5DEF-639C-41E1-BDEF-EF00969C38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9790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326EE8B-4283-2205-78FD-2870AC686618}"/>
              </a:ext>
            </a:extLst>
          </p:cNvPr>
          <p:cNvSpPr txBox="1"/>
          <p:nvPr/>
        </p:nvSpPr>
        <p:spPr>
          <a:xfrm>
            <a:off x="1251156" y="3928439"/>
            <a:ext cx="445298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21912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326EE8B-4283-2205-78FD-2870AC686618}"/>
              </a:ext>
            </a:extLst>
          </p:cNvPr>
          <p:cNvSpPr txBox="1"/>
          <p:nvPr/>
        </p:nvSpPr>
        <p:spPr>
          <a:xfrm>
            <a:off x="2540461" y="4093031"/>
            <a:ext cx="32202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log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29904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94A7BB-025E-610F-6DBD-13834DA79F6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Ein Bild, das Karte, Kachel enthält.&#10;&#10;Automatisch generierte Beschreibung">
            <a:extLst>
              <a:ext uri="{FF2B5EF4-FFF2-40B4-BE49-F238E27FC236}">
                <a16:creationId xmlns:a16="http://schemas.microsoft.com/office/drawing/2014/main" id="{3CC5D6C7-9A9E-20FC-8AA9-5A43D8397F04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093" y="409296"/>
            <a:ext cx="6093172" cy="5470296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03EC2548-E70C-3B4E-A88F-B804B65D0F38}"/>
              </a:ext>
            </a:extLst>
          </p:cNvPr>
          <p:cNvSpPr txBox="1"/>
          <p:nvPr/>
        </p:nvSpPr>
        <p:spPr>
          <a:xfrm>
            <a:off x="329093" y="6025896"/>
            <a:ext cx="606236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6,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trotyrosine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53 positivity in granulomas. a-d and f are DAB based brown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s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 and g are alkaline phosphatase based red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s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xemplary giant cells are highlighted (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). (a) Ill-defined, immature granuloma with high density of BCL6-positive nuclei in giant cells and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theloid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(c) Mature granulomas with very low numbers of BCL6-positive nuclei. (b, d, f) Different densities of p53 nuclei inside giant cells: (b) Giant cell with high density of p53+ nuclei, (d) intermediate density, (f) very low density. (e, g) Exemplary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trotyrosine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ositive granuloma walls due to positive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theloid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giant cells (g displays a higher magnification). Magnifications indicated by bar (a, b, e, f, g: 20 µm; c: 50 µm; d: 10 µm). Original resolution: 0.465 µm per pixel.</a:t>
            </a:r>
          </a:p>
        </p:txBody>
      </p:sp>
    </p:spTree>
    <p:extLst>
      <p:ext uri="{BB962C8B-B14F-4D97-AF65-F5344CB8AC3E}">
        <p14:creationId xmlns:p14="http://schemas.microsoft.com/office/powerpoint/2010/main" val="36539016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326EE8B-4283-2205-78FD-2870AC686618}"/>
              </a:ext>
            </a:extLst>
          </p:cNvPr>
          <p:cNvSpPr txBox="1"/>
          <p:nvPr/>
        </p:nvSpPr>
        <p:spPr>
          <a:xfrm>
            <a:off x="2540461" y="4093031"/>
            <a:ext cx="32202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421160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5731C656-402A-047D-9E8A-D6D8DF7F7A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7600492"/>
              </p:ext>
            </p:extLst>
          </p:nvPr>
        </p:nvGraphicFramePr>
        <p:xfrm>
          <a:off x="329184" y="265176"/>
          <a:ext cx="6199632" cy="54353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80566">
                  <a:extLst>
                    <a:ext uri="{9D8B030D-6E8A-4147-A177-3AD203B41FA5}">
                      <a16:colId xmlns:a16="http://schemas.microsoft.com/office/drawing/2014/main" val="1170096454"/>
                    </a:ext>
                  </a:extLst>
                </a:gridCol>
                <a:gridCol w="4719066">
                  <a:extLst>
                    <a:ext uri="{9D8B030D-6E8A-4147-A177-3AD203B41FA5}">
                      <a16:colId xmlns:a16="http://schemas.microsoft.com/office/drawing/2014/main" val="1830534545"/>
                    </a:ext>
                  </a:extLst>
                </a:gridCol>
              </a:tblGrid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breviatio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ole Feature </a:t>
                      </a:r>
                      <a:r>
                        <a:rPr lang="en-US" sz="10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extLst>
                  <a:ext uri="{0D108BD9-81ED-4DB2-BD59-A6C34878D82A}">
                    <a16:rowId xmlns:a16="http://schemas.microsoft.com/office/drawing/2014/main" val="2059036556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cell lymphoma 2</a:t>
                      </a: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99313358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cell lymphoma 6</a:t>
                      </a: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474333750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6 ratio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Bcl6 positive nuclei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4058546193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cluster wall medi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number of CD4+ T-cells forming a cluster inside the granuloma wal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extLst>
                  <a:ext uri="{0D108BD9-81ED-4DB2-BD59-A6C34878D82A}">
                    <a16:rowId xmlns:a16="http://schemas.microsoft.com/office/drawing/2014/main" val="2969677275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peri gran dt mean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aunay: Mean distance between CD4+ T-cells in the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igranulomatous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e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extLst>
                  <a:ext uri="{0D108BD9-81ED-4DB2-BD59-A6C34878D82A}">
                    <a16:rowId xmlns:a16="http://schemas.microsoft.com/office/drawing/2014/main" val="319902389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peri gran/TZ dt mean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aunay: Ratio of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igranulomatous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ea / T-zone: Mean distance between CD4+ T-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extLst>
                  <a:ext uri="{0D108BD9-81ED-4DB2-BD59-A6C34878D82A}">
                    <a16:rowId xmlns:a16="http://schemas.microsoft.com/office/drawing/2014/main" val="3652651624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peri gran/TZ </a:t>
                      </a:r>
                      <a:r>
                        <a:rPr lang="it-IT" sz="8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</a:t>
                      </a:r>
                      <a:r>
                        <a:rPr lang="it-IT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8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it-IT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aunay: Ratio of 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igranulomatous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ea / T-zone: Mean number of CD4+ neighbor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extLst>
                  <a:ext uri="{0D108BD9-81ED-4DB2-BD59-A6C34878D82A}">
                    <a16:rowId xmlns:a16="http://schemas.microsoft.com/office/drawing/2014/main" val="484158015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wall/TZ dt max</a:t>
                      </a: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aunay: Ratio of granuloma wall / T-zone: Mean maximum distance of CD4+ neighbor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extLst>
                  <a:ext uri="{0D108BD9-81ED-4DB2-BD59-A6C34878D82A}">
                    <a16:rowId xmlns:a16="http://schemas.microsoft.com/office/drawing/2014/main" val="39495285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 wall/TZ </a:t>
                      </a:r>
                      <a:r>
                        <a:rPr lang="en-US" sz="8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</a:t>
                      </a:r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dian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aunay: Ratio of granuloma wall / T-zone: Median number of CD4+ neighbors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extLst>
                  <a:ext uri="{0D108BD9-81ED-4DB2-BD59-A6C34878D82A}">
                    <a16:rowId xmlns:a16="http://schemas.microsoft.com/office/drawing/2014/main" val="2288242467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/CD8 nec me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 CD4 / CD8: Mean number of  positive cells per mm^2 in the granuloma necrosi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1425723027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/CD8 peri gran </a:t>
                      </a:r>
                      <a:r>
                        <a:rPr lang="it-IT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 CD4 / CD8: Mean number of  positive cells per mm^2 in the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igranulomatous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e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1403678031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/CD8 TZ me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 CD4 / CD8: Mean number of  positive cells per mm^2 in the </a:t>
                      </a:r>
                      <a:r>
                        <a:rPr lang="fr-F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-</a:t>
                      </a:r>
                      <a:r>
                        <a:rPr lang="fr-FR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</a:t>
                      </a:r>
                      <a:r>
                        <a:rPr lang="fr-F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zone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242155044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/CD8 wall me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 CD4 / CD8: Mean number of  positive cells per mm^2 in the granuloma wal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1625742525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nec me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number of CD8+ per mm^2 in the granuloma necrosi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497856221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nec/TZ me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 granuloma necrosis / T-cell zone: Mean numbers of CD8+ positive cells per mm^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973583581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peri gran me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number of CD8+ per mm^2 in the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igranulomatous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e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879915617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it-IT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peri gran/TZ mean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io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igranulomatous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rea / T-cell zone: Mean numbers of CD8+ positive cells per mm^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451041653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score in gr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+ T-cell density (aim for necrosis and set positive cells in relation to the positive cells inside the granuloma wall: IC 0: &lt;0.1%, IC 1: 0.1-0.4%, IC 2: 0.5-0.9%, IC 3: 1-100%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796129777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wall medi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number of CD8+ per mm^2 in the granuloma wal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1260671467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liquefac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s of liquefac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2240416995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licated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rse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posite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omp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1898855301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max gr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de-DE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</a:t>
                      </a:r>
                      <a:r>
                        <a:rPr lang="de-DE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nuloma</a:t>
                      </a:r>
                      <a:r>
                        <a:rPr lang="de-DE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meter</a:t>
                      </a:r>
                      <a:r>
                        <a:rPr lang="de-DE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% HPF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1886587710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am epi-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am cell aspect: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theloid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2920724050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V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eld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ew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426854902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-c none gr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nulomas present without giant 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904358868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W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od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und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ing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posite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paired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und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ing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IWH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89396773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ldef gr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nulomas are irregularly limite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44333886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ndiama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lymph node siz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80688941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fo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mph follicles prese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976529692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 nuclei 10 gi-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number of nuclei in one giant cell out of 10 giant 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49938820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n nuclei gi-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number of nuclei from 20 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ant 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2913352478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bcl2 gi-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Bcl2 positives from 10 giant 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2625638048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bcl6 gi-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Bcl6 positives from 10 giant 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559194974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GC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germinal center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407916988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gr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granulomas in 10x objective le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186578135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gran p53 gi-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3: How many granulomas do the 10 giant cells come from? If possible, out of as many as possible (max. 10)!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2883988448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nuclei 10 gi-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number of nuclei from 10 giant 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3205710383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nuclei p53 gi-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53 positive nuclei from 10 giant 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41486475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c gr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crotize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41251488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3 rati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p53 positive nucle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1251964415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in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in color change (skin col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581419828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lldef gr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nulomas with sharply demarcated borde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0" marR="940" marT="940" marB="0"/>
                </a:tc>
                <a:extLst>
                  <a:ext uri="{0D108BD9-81ED-4DB2-BD59-A6C34878D82A}">
                    <a16:rowId xmlns:a16="http://schemas.microsoft.com/office/drawing/2014/main" val="22643340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23178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703332C-3D5E-E12B-10C9-BA5A7D896D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3DA9778-E6C1-F098-F550-BEEF779306B4}"/>
              </a:ext>
            </a:extLst>
          </p:cNvPr>
          <p:cNvSpPr txBox="1"/>
          <p:nvPr/>
        </p:nvSpPr>
        <p:spPr>
          <a:xfrm>
            <a:off x="2266140" y="3919295"/>
            <a:ext cx="445298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me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urse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olution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nical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mptoms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84121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7829" y="2338086"/>
            <a:ext cx="5772900" cy="3518884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EF21091B-A6C2-2BBB-AFC2-F5713DC22239}"/>
              </a:ext>
            </a:extLst>
          </p:cNvPr>
          <p:cNvSpPr txBox="1"/>
          <p:nvPr/>
        </p:nvSpPr>
        <p:spPr>
          <a:xfrm>
            <a:off x="295733" y="5856970"/>
            <a:ext cx="644652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 Time to resolution of clinical symptoms in the NTM Kids cohort for individuals also part of the present study (median 13 months, 95% confidence (CI) interval 8 to 18 months) vs for those not part of the histological evaluation (median 8 months, CI 7 to 12 months).</a:t>
            </a:r>
            <a:endParaRPr lang="en-US" sz="1000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28037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F61229A-164D-AE2F-391A-BF5BAFE7084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08C4D80-DB5C-9895-0360-32C8EFE50610}"/>
              </a:ext>
            </a:extLst>
          </p:cNvPr>
          <p:cNvSpPr txBox="1"/>
          <p:nvPr/>
        </p:nvSpPr>
        <p:spPr>
          <a:xfrm>
            <a:off x="2266140" y="3919295"/>
            <a:ext cx="445298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ociation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ound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ling (</a:t>
            </a:r>
            <a:r>
              <a:rPr lang="de-DE" sz="1200" b="1" err="1">
                <a:latin typeface="Times New Roman" panose="02020603050405020304" pitchFamily="18" charset="0"/>
                <a:cs typeface="Times New Roman" panose="02020603050405020304" pitchFamily="18" charset="0"/>
              </a:rPr>
              <a:t>good</a:t>
            </a:r>
            <a:r>
              <a:rPr lang="de-DE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paired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logic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atures</a:t>
            </a:r>
          </a:p>
        </p:txBody>
      </p:sp>
    </p:spTree>
    <p:extLst>
      <p:ext uri="{BB962C8B-B14F-4D97-AF65-F5344CB8AC3E}">
        <p14:creationId xmlns:p14="http://schemas.microsoft.com/office/powerpoint/2010/main" val="10705108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AD4ED8-38E3-A82F-BD84-2B08730D58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 descr="Ein Bild, das Text, Diagramm, Plan, Karte enthält.&#10;&#10;Automatisch generierte Beschreibung">
            <a:extLst>
              <a:ext uri="{FF2B5EF4-FFF2-40B4-BE49-F238E27FC236}">
                <a16:creationId xmlns:a16="http://schemas.microsoft.com/office/drawing/2014/main" id="{61AB4D97-313A-64FB-28B5-96C379B486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5750"/>
            <a:ext cx="6858000" cy="6858000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A34BD530-AF7C-5870-28EA-4426BAF527BF}"/>
              </a:ext>
            </a:extLst>
          </p:cNvPr>
          <p:cNvSpPr txBox="1"/>
          <p:nvPr/>
        </p:nvSpPr>
        <p:spPr>
          <a:xfrm>
            <a:off x="388620" y="7143750"/>
            <a:ext cx="608076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across the risk groups of outcome of wound healing GWH (n = 18) and IWH (n = 15). Abbreviations are provided 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page 13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(unadjusted) p-values from the Wilcoxon-Mann-Whitney test and the correlations with the outcome, as shown in this figure, were used solely to select the depicted variables. Since none of the adjusted p-values are statistically significant, these variables alone are unlikely to contribute to the observed differences between outcome classes substantially. </a:t>
            </a:r>
          </a:p>
        </p:txBody>
      </p:sp>
    </p:spTree>
    <p:extLst>
      <p:ext uri="{BB962C8B-B14F-4D97-AF65-F5344CB8AC3E}">
        <p14:creationId xmlns:p14="http://schemas.microsoft.com/office/powerpoint/2010/main" val="16954066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703332C-3D5E-E12B-10C9-BA5A7D896D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3DA9778-E6C1-F098-F550-BEEF779306B4}"/>
              </a:ext>
            </a:extLst>
          </p:cNvPr>
          <p:cNvSpPr txBox="1"/>
          <p:nvPr/>
        </p:nvSpPr>
        <p:spPr>
          <a:xfrm>
            <a:off x="2266140" y="3919295"/>
            <a:ext cx="445298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ociation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urse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ease (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complicated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licated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logic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atures</a:t>
            </a:r>
          </a:p>
        </p:txBody>
      </p:sp>
    </p:spTree>
    <p:extLst>
      <p:ext uri="{BB962C8B-B14F-4D97-AF65-F5344CB8AC3E}">
        <p14:creationId xmlns:p14="http://schemas.microsoft.com/office/powerpoint/2010/main" val="3912383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DEABFF3-7DC6-1415-41E9-4A958BE6D3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 descr="Ein Bild, das Text, Diagramm, Plan, Design enthält.&#10;&#10;Automatisch generierte Beschreibung">
            <a:extLst>
              <a:ext uri="{FF2B5EF4-FFF2-40B4-BE49-F238E27FC236}">
                <a16:creationId xmlns:a16="http://schemas.microsoft.com/office/drawing/2014/main" id="{F7D8CA4D-F22F-14FC-6210-EECC4EE8A3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170"/>
            <a:ext cx="6858000" cy="8875059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EF21091B-A6C2-2BBB-AFC2-F5713DC22239}"/>
              </a:ext>
            </a:extLst>
          </p:cNvPr>
          <p:cNvSpPr txBox="1"/>
          <p:nvPr/>
        </p:nvSpPr>
        <p:spPr>
          <a:xfrm>
            <a:off x="411480" y="8878278"/>
            <a:ext cx="644652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across the risk groups of outcome of the course of the disease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omp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=9) and Comp (n=24) . Abbreviations are provided 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page 13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(unadjusted) p-values from the Wilcoxon-Mann-Whitney test and the correlations with the outcome, as shown in this figure, were used solely to select the depicted variables. Since none of the adjusted p-values are statistically significant, these variables alone are unlikely to contribute to the observed differences between outcome classes substantially. </a:t>
            </a:r>
          </a:p>
        </p:txBody>
      </p:sp>
    </p:spTree>
    <p:extLst>
      <p:ext uri="{BB962C8B-B14F-4D97-AF65-F5344CB8AC3E}">
        <p14:creationId xmlns:p14="http://schemas.microsoft.com/office/powerpoint/2010/main" val="35098256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DB8128-8ECF-FC0B-7BFC-E56F5664B1E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1C260B4-0B34-C03E-0285-5D138DEBF66A}"/>
              </a:ext>
            </a:extLst>
          </p:cNvPr>
          <p:cNvSpPr txBox="1"/>
          <p:nvPr/>
        </p:nvSpPr>
        <p:spPr>
          <a:xfrm>
            <a:off x="2266140" y="3919295"/>
            <a:ext cx="445298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w and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justed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-Values</a:t>
            </a:r>
          </a:p>
        </p:txBody>
      </p:sp>
    </p:spTree>
    <p:extLst>
      <p:ext uri="{BB962C8B-B14F-4D97-AF65-F5344CB8AC3E}">
        <p14:creationId xmlns:p14="http://schemas.microsoft.com/office/powerpoint/2010/main" val="17700682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13349A2-18C5-9B61-81EA-D968D4DF474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19BC727E-7873-2468-408E-3572F476A283}"/>
              </a:ext>
            </a:extLst>
          </p:cNvPr>
          <p:cNvSpPr txBox="1"/>
          <p:nvPr/>
        </p:nvSpPr>
        <p:spPr>
          <a:xfrm>
            <a:off x="340360" y="8431238"/>
            <a:ext cx="63042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distributions of raw and adjusted p-values (using the Benjamini-Hochberg correction). Upper panel: correlation; lower panel: Wilcoxon-Mann-Whitney.</a:t>
            </a:r>
            <a:endParaRPr lang="en-US" sz="1000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fik 4" descr="Ein Bild, das Text, Screenshot, Diagramm, Reihe enthält.&#10;&#10;KI-generierte Inhalte können fehlerhaft sein.">
            <a:extLst>
              <a:ext uri="{FF2B5EF4-FFF2-40B4-BE49-F238E27FC236}">
                <a16:creationId xmlns:a16="http://schemas.microsoft.com/office/drawing/2014/main" id="{F61FDB43-29B1-945D-3079-C719F228589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840" y="806028"/>
            <a:ext cx="5608320" cy="3364992"/>
          </a:xfrm>
          <a:prstGeom prst="rect">
            <a:avLst/>
          </a:prstGeom>
        </p:spPr>
      </p:pic>
      <p:pic>
        <p:nvPicPr>
          <p:cNvPr id="7" name="Grafik 6" descr="Ein Bild, das Text, Screenshot, Diagramm, Reihe enthält.&#10;&#10;KI-generierte Inhalte können fehlerhaft sein.">
            <a:extLst>
              <a:ext uri="{FF2B5EF4-FFF2-40B4-BE49-F238E27FC236}">
                <a16:creationId xmlns:a16="http://schemas.microsoft.com/office/drawing/2014/main" id="{E860B093-69F1-ACD4-2790-4AB8073B007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840" y="4920828"/>
            <a:ext cx="5608320" cy="3364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0579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054</Words>
  <Application>Microsoft Office PowerPoint</Application>
  <PresentationFormat>A4-Papier (210 x 297 mm)</PresentationFormat>
  <Paragraphs>98</Paragraphs>
  <Slides>1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</dc:title>
  <dc:creator>Maximilian Seidl</dc:creator>
  <cp:lastModifiedBy>Dr. Martin Kuntz</cp:lastModifiedBy>
  <cp:revision>51</cp:revision>
  <dcterms:created xsi:type="dcterms:W3CDTF">2024-01-09T11:10:21Z</dcterms:created>
  <dcterms:modified xsi:type="dcterms:W3CDTF">2025-05-31T21:07:22Z</dcterms:modified>
</cp:coreProperties>
</file>